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4916D-EE70-C7EA-1880-7892E9EA31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77238AE-5E44-2316-20C1-0AE9755D13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62402-D515-8716-7ADE-715C517D9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28777D-800E-60ED-C021-D7DFB806D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75C488-88C3-04AC-FDB2-155692007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582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3234A-0308-E0AF-0527-58AED7981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64BEE9-DE57-4470-E8DE-9A4F99B152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BBCAEA-4D59-26F0-66D1-F93D4E071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890CFF-AF60-8B1F-E0C9-745C93DBA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429ECF-0E9D-F6BA-3B5E-4B0252EE2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859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C5E70F-80EA-4BC6-AEB0-CF1FC67FD3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49984B-05C5-1151-066D-50DD532258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5626E8-2F55-55C8-ABD8-8F0415A5D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D3D445-571A-5737-1201-98C26570F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B050E2-5B11-9252-6DDF-284EAF59F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652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A1F43A-514C-1B05-D305-4145CA4911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1FE4F8-0784-617B-0234-07BE226EDB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423225-E319-5E4E-9E1B-E7ED51D86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8B0172-EDA6-C8F3-983B-075CF39B9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8269F8-9885-C66E-8E99-7658198BC1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64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8C161-35A7-85E0-64F4-D382E30FB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66D4C6-68A0-13C3-16DC-826BC21EB2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94464D-7C99-9EAD-E0B6-BA4DC2C56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8A7150-7E29-B011-E6BF-95AEB85B5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0A6946-679D-3399-99E6-2EB00E7A6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366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F79CB-860B-5A94-EDDA-BA967DD6B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948CF7-DD14-FB55-396A-5C6B77B73C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B8727B-E918-FBE7-3A49-3954E321B1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8B5098-CD7E-F760-3F61-73FC77B8F8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D344C2-EF27-95EA-AB97-46C555039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2F9A98-C3DA-B22E-A078-FC47F6222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287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5150FF-D509-AE06-AB0A-A650749BD5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A9D2F3-E341-B832-8F77-FC6256399C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A1FD23-753D-7974-D295-48EA851B83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2FC84F-DD1F-ECCB-9845-43DA195028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6DAA84-A51A-A5C6-6275-409E40D293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A7D60E-FBFF-5CB4-F11E-334FAED65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CF59A9-7FDF-13EA-F249-A27603DAA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316D6A-CB12-386C-D4AE-5C16DB802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428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9F63B7-9FC9-D82F-08B2-320A6F6403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807D25-EF8A-00B2-6A2F-00F8622129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FF4E9C-11BE-B26B-DB15-12DBDCA00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511F7D-A67F-760C-C859-8488F2516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54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8E76C1-6510-A60F-21C3-EF02F64CA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087E49-6C43-8CE9-5C24-75B54FDE3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40D3A0-96C5-251B-C7C1-0BC37CD41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659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EC58FD-5457-BB39-7439-05FB6F90F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AD5918-F0E1-6591-B785-108447A05B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F3F180-30FF-C7FC-1292-88E3493FF9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279922-14C8-EFDB-6D27-C0D099F282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0C09F1-480D-1C92-F9FB-532F3A2B5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C221C0-2A14-EE8B-897A-3EEA8A33E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830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863725-9E59-5573-7A78-770FEC2890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D194B1-9F8F-DEA1-D887-FE73CE2DDD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6DF591-9C8F-F6F1-E071-49A1C0A56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E920BA-4D17-B452-233C-183567F08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1F3E7B-179C-DF43-60AD-137B3CF02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832260-CAA0-D4D8-6E99-C29CF7820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627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A69BB9-1F17-E4DD-CE9F-7FCEDF75D9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D7FC33-9549-BAA6-D909-E06B90E5CD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90A33B-5CA8-21C1-3559-F86B2D76CD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505B3B-B9FA-46B7-88C7-7B476546AFCD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18D8BB-B801-B3F9-01FB-7E0B90ADD1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9F04D0-67DD-FD8E-8DF2-45B57B2193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EB78AC-83CD-454D-9FFE-C30155E111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964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336883" y="1146438"/>
          <a:ext cx="11569568" cy="3987165"/>
        </p:xfrm>
        <a:graphic>
          <a:graphicData uri="http://schemas.openxmlformats.org/drawingml/2006/table">
            <a:tbl>
              <a:tblPr/>
              <a:tblGrid>
                <a:gridCol w="2897206">
                  <a:extLst>
                    <a:ext uri="{9D8B030D-6E8A-4147-A177-3AD203B41FA5}">
                      <a16:colId xmlns:a16="http://schemas.microsoft.com/office/drawing/2014/main" val="1617085600"/>
                    </a:ext>
                  </a:extLst>
                </a:gridCol>
                <a:gridCol w="1068404">
                  <a:extLst>
                    <a:ext uri="{9D8B030D-6E8A-4147-A177-3AD203B41FA5}">
                      <a16:colId xmlns:a16="http://schemas.microsoft.com/office/drawing/2014/main" val="2018041585"/>
                    </a:ext>
                  </a:extLst>
                </a:gridCol>
                <a:gridCol w="7603958">
                  <a:extLst>
                    <a:ext uri="{9D8B030D-6E8A-4147-A177-3AD203B41FA5}">
                      <a16:colId xmlns:a16="http://schemas.microsoft.com/office/drawing/2014/main" val="103812139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ogical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cou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tching proteins in the pathway networ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3819525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1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nate immune respon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APCS,C1QB,CD44,HLA-A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07174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I interferon signaling pathwa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A-A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45391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ense respon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APCS,C1QB,CD44,HLA-A,HP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46259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kine-mediated signaling pathwa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CD44,HLA-A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20234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e effector proces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1QB,CD44,HLA-A,HP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93409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response to cytokine stimul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CD44,COL1A1,HLA-A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709272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ense response to vir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922802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e respons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APCS,C1QB,CD44,HLA-A,HP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79079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ense response to other organis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A-A,HP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29115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feron-gamma-mediated signaling pathwa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,HLA-A,ICAM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069252"/>
                  </a:ext>
                </a:extLst>
              </a:tr>
              <a:tr h="14112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response to chemical stimul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BLM,CD44,COL1A1,HLA-A, HP,ICAM1,IFIT1,IFIT2,IFIT3,ISG15,MX1,NQO1,OAS2,SH3BP4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3648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other organis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LA-A,HP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89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e system proces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APCS,C1QB,CD44,COL1A1,HLA-A,HP,ICAM1,IFIT1,IFIT2,IFIT3,ISG15,MX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35274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 regulation of viral proces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S,IFIT1,ISG15,MX1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801621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external stimul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COL1A1,HLA-A,HP,ICAM1,IFIT1,IFIT2,IFIT3,ISG15,MX1,NQO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5490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ular response to organic substan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BLM,CD44,COL1A1,HLA-A,ICAM1,IFIT1,IFIT2,IFIT3,ISG15,MX1,OAS2,SH3BP4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265824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organic substanc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BLM,CD44,COL1A1,HLA-A,ICAM1,IFIT1,IFIT2,IFIT3,ISG15,MX1,NQO1,OAS2,SH3BP4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27027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antibioti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COL1A1,HP,ICAM1,NQO1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011670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1" u="sng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stres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APCS,BLM,C1QB,CD44,COL1A1,GFAP,HLA-A,HP,ICAM1,IFIT1,IFIT2,IFIT3,ISG15,MX1,NQO1,OAS2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741702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ponse to hydrogen peroxid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XA1,COL1A1,HP,NQO1,STAT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131581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42955" y="869439"/>
            <a:ext cx="4361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7 Table. Biological pathways identified in HAND brains.</a:t>
            </a:r>
          </a:p>
        </p:txBody>
      </p:sp>
    </p:spTree>
    <p:extLst>
      <p:ext uri="{BB962C8B-B14F-4D97-AF65-F5344CB8AC3E}">
        <p14:creationId xmlns:p14="http://schemas.microsoft.com/office/powerpoint/2010/main" val="578676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9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2:24Z</dcterms:created>
  <dcterms:modified xsi:type="dcterms:W3CDTF">2025-07-28T20:02:52Z</dcterms:modified>
</cp:coreProperties>
</file>